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  <p:sldId id="264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2" d="100"/>
          <a:sy n="92" d="100"/>
        </p:scale>
        <p:origin x="34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884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543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634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102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254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707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558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716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3386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78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815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073DF-C31F-0946-A184-9BE0744E511D}" type="datetimeFigureOut">
              <a:rPr lang="en-US" smtClean="0"/>
              <a:t>2/2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72A547-DC9C-2E42-B539-5755014FE3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9001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8C8F6149-26BA-7F47-47A2-A077D91308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252" y="126204"/>
            <a:ext cx="3184725" cy="55732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F84700B-C54A-50F4-DC6B-E4D49CF507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7825" y="126205"/>
            <a:ext cx="2786637" cy="557327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FDD70FA-B426-DB35-16C6-94D82BF23065}"/>
              </a:ext>
            </a:extLst>
          </p:cNvPr>
          <p:cNvSpPr txBox="1"/>
          <p:nvPr/>
        </p:nvSpPr>
        <p:spPr>
          <a:xfrm rot="5400000">
            <a:off x="2667878" y="901644"/>
            <a:ext cx="1346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Dye decolorizat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037EF83-1FDB-B8E7-BF8F-6FB56CC313BF}"/>
              </a:ext>
            </a:extLst>
          </p:cNvPr>
          <p:cNvSpPr txBox="1"/>
          <p:nvPr/>
        </p:nvSpPr>
        <p:spPr>
          <a:xfrm rot="5400000">
            <a:off x="5980928" y="884226"/>
            <a:ext cx="6190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C8AA1AC-315C-F0F8-CE06-BDC7B5C47928}"/>
              </a:ext>
            </a:extLst>
          </p:cNvPr>
          <p:cNvSpPr txBox="1"/>
          <p:nvPr/>
        </p:nvSpPr>
        <p:spPr>
          <a:xfrm>
            <a:off x="113253" y="5898190"/>
            <a:ext cx="67447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1. Phenotype clustering of all fungal isolates. Heatmap and Hierarchical clustering of dye-decolorization level over 10 days in the 320 fungal isolates (left). The growth level of each fungal isolate over 10 days was shown in the same order on right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FE0DD23-C9C3-20D1-C51D-BE2BB622F98C}"/>
              </a:ext>
            </a:extLst>
          </p:cNvPr>
          <p:cNvSpPr txBox="1"/>
          <p:nvPr/>
        </p:nvSpPr>
        <p:spPr>
          <a:xfrm>
            <a:off x="1437277" y="5568673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55F4941-35BB-2DFA-3D1C-27A7FDA1D75B}"/>
              </a:ext>
            </a:extLst>
          </p:cNvPr>
          <p:cNvSpPr txBox="1"/>
          <p:nvPr/>
        </p:nvSpPr>
        <p:spPr>
          <a:xfrm>
            <a:off x="4682443" y="5568673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3832653-D1EF-DA83-D17B-0628BA8D30D8}"/>
              </a:ext>
            </a:extLst>
          </p:cNvPr>
          <p:cNvCxnSpPr>
            <a:cxnSpLocks/>
          </p:cNvCxnSpPr>
          <p:nvPr/>
        </p:nvCxnSpPr>
        <p:spPr>
          <a:xfrm>
            <a:off x="88300" y="4363968"/>
            <a:ext cx="6075210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931734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3FC8608-5CFA-A774-AC9E-FA6EC0739521}"/>
              </a:ext>
            </a:extLst>
          </p:cNvPr>
          <p:cNvSpPr txBox="1"/>
          <p:nvPr/>
        </p:nvSpPr>
        <p:spPr>
          <a:xfrm>
            <a:off x="0" y="1926802"/>
            <a:ext cx="6705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2. The Pearson’s correlation coefficient between dye decolorization level and growth level in the fast decomposition isolate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2A43558-F153-CB25-BDC0-B48E5B59EE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9526"/>
            <a:ext cx="6858000" cy="18703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4148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72</Words>
  <Application>Microsoft Macintosh PowerPoint</Application>
  <PresentationFormat>Letter Paper (8.5x11 in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, Jiali</dc:creator>
  <cp:lastModifiedBy>Yu, Jiali</cp:lastModifiedBy>
  <cp:revision>2</cp:revision>
  <dcterms:created xsi:type="dcterms:W3CDTF">2023-01-25T20:03:00Z</dcterms:created>
  <dcterms:modified xsi:type="dcterms:W3CDTF">2023-02-27T17:19:58Z</dcterms:modified>
</cp:coreProperties>
</file>